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A040"/>
    <a:srgbClr val="55A0FB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E19196-A784-9D64-AFE9-9F9CC64E9C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BBC94A8-EF44-8A0A-1661-F1A4F374DD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A037480-CC22-7F13-480A-D3CD40CD5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ECD6976-0BFC-B3BD-BD9A-BE89364A2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FE80D3F-5E70-55CF-00B7-7F94346CF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4192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94E7B50-6711-954B-7F6D-C2B89D65DE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2F89F6E-E1CD-93B2-7B39-769EAE45E5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DAA5416-0968-F11A-4119-D7A514860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576D6CB-7845-AA8E-C6FF-B6AC761E2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C867E78-C164-8167-CC27-E53A1AD0E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7190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3355020-7C76-E1ED-3997-230C28E09F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51A59CF-E825-850D-B42D-4FAEF59B80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2279E4A-E608-22F0-550B-8BF817376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8352EAA-5ECF-2338-FD9E-6CAFB0D07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7653441-50AA-F437-E665-60E87CF4B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046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6E5AA4-D76C-268A-6C54-C5491177B8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6EB5A48-A143-C842-2CAC-CB7F229A95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AC4721B-AF28-E925-B1A6-84BEEC829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830F58E-3338-542E-52FB-1F89CBA2C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F148DA1-A633-3386-5A74-C36939321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7954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CD4D6A-D105-8A00-DFF7-A35383FED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95CB9CB-55D7-2BD3-60CC-03361BE1EA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6D5673A-8A2D-7326-604A-A8BDE57B8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741326-3F47-C3F0-A504-9CDCA8F3A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63C9774-2A84-4E66-F192-860D01E1C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3904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5E5CE3-4778-0C45-022B-606245EF0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5727497-FB50-39B4-0086-1A2A5CDB9B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CB8ADB0-0E2F-0669-7B1B-B47F444295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1B5C1F4-5656-ABBC-26F0-091A8D8CD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15E94AD-5BBD-E743-AAE1-D79DDF870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CEF3F5A-D508-7B8A-877B-604840A92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3186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23F2E8-FEAB-9EE6-38E7-41B8D5D29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65E1B23-527C-20EE-5A5D-9EF686CCF8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0C4B4CA-0564-D20B-C7D9-E305D0C76F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1861AFC-01D6-B1D3-F334-7F4EF95C0C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AA2A3C0-A6BC-CFEA-1BA5-D2D091BCFD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580D4D0-E7AC-095D-8189-E8B1E1917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9826D11-32ED-1EA7-6828-4A4FFB829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DA3785C-68AA-DC2C-B138-B6AF679D1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1749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7BD5742-4287-8057-A191-6A053F4E38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E2C7FDE-190E-26DD-F34F-9C9263B9D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12296E2-95E1-1F2A-70C8-FA3A3D76F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16739AE-FC5D-4B79-16C5-01AB0BF4D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8731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9C7174E-5FDB-DD9C-E6A7-7FC226F3D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3C7E267-4700-F33D-8EE1-96678D56F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325A6F9-4A30-50AD-B188-8232EFB67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218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392367-01E8-206E-5507-BBF59F3AD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BA3CAA3-1FAC-AE78-A0F2-93F1AB9286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A45E53A-6AF0-62F1-4C2C-C5EEF88597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1D5E01A-579A-394C-C9FE-C42892EEE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76D734F-5A7E-41E0-175C-1CBB4AB95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270A3A6-D082-D575-F799-4A1846CA9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0362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FBAB11-2E27-58D6-EF3D-B48A9822F0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F4CFB158-BE9A-D8C6-B7C9-1BD3F9A19E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E8BCFE4-B204-3516-1948-82DA32BBD5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238403A-2655-BAE8-2DCD-7453E2BF3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388B78C-0FAB-9A09-DC99-989AC76DC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6D278E3-F04E-953B-3527-1F7346873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8262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C1717B5-E4FE-97FF-0346-85213A6C9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00ACD64-039A-15CD-450C-FB9CF31AE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BF87231-CD82-C03B-E839-39972D33BF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63150-E30A-4B7C-B836-F6D082E006BA}" type="datetimeFigureOut">
              <a:rPr lang="de-DE" smtClean="0"/>
              <a:t>19.07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EFCAFCF-C32B-30FE-2E2B-ACAFF2BFBE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2ECC53F-0BA2-9DFB-775D-17F19E73FB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631EF-A6EB-4B7C-8CED-D8DDC6D4106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3710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 descr="Ein Bild, das Screenshot, Schwarz, Schwarzweiß, monochrom enthält.&#10;&#10;Automatisch generierte Beschreibung">
            <a:extLst>
              <a:ext uri="{FF2B5EF4-FFF2-40B4-BE49-F238E27FC236}">
                <a16:creationId xmlns:a16="http://schemas.microsoft.com/office/drawing/2014/main" id="{57618A09-FDBD-EE28-6D25-08F7E62FED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8897" y="2085046"/>
            <a:ext cx="3701766" cy="2687907"/>
          </a:xfrm>
          <a:prstGeom prst="rect">
            <a:avLst/>
          </a:prstGeom>
        </p:spPr>
      </p:pic>
      <p:pic>
        <p:nvPicPr>
          <p:cNvPr id="5" name="Grafik 4" descr="Ein Bild, das Screenshot, Schwarz, Schwarzweiß, monochrom enthält.&#10;&#10;Automatisch generierte Beschreibung">
            <a:extLst>
              <a:ext uri="{FF2B5EF4-FFF2-40B4-BE49-F238E27FC236}">
                <a16:creationId xmlns:a16="http://schemas.microsoft.com/office/drawing/2014/main" id="{FEF4CFEE-5ADC-8D4D-2B83-6503E6AB38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5951" y="2085047"/>
            <a:ext cx="3701766" cy="2687906"/>
          </a:xfrm>
          <a:prstGeom prst="rect">
            <a:avLst/>
          </a:prstGeom>
        </p:spPr>
      </p:pic>
      <p:cxnSp>
        <p:nvCxnSpPr>
          <p:cNvPr id="3" name="Gerade Verbindung mit Pfeil 2">
            <a:extLst>
              <a:ext uri="{FF2B5EF4-FFF2-40B4-BE49-F238E27FC236}">
                <a16:creationId xmlns:a16="http://schemas.microsoft.com/office/drawing/2014/main" id="{47777B6B-EA23-8FC8-9375-1798DC2D2917}"/>
              </a:ext>
            </a:extLst>
          </p:cNvPr>
          <p:cNvCxnSpPr/>
          <p:nvPr/>
        </p:nvCxnSpPr>
        <p:spPr>
          <a:xfrm>
            <a:off x="7265773" y="3595816"/>
            <a:ext cx="42013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mit Pfeil 6">
            <a:extLst>
              <a:ext uri="{FF2B5EF4-FFF2-40B4-BE49-F238E27FC236}">
                <a16:creationId xmlns:a16="http://schemas.microsoft.com/office/drawing/2014/main" id="{DFB3847A-62C6-AE9C-2454-320298E84DB8}"/>
              </a:ext>
            </a:extLst>
          </p:cNvPr>
          <p:cNvCxnSpPr/>
          <p:nvPr/>
        </p:nvCxnSpPr>
        <p:spPr>
          <a:xfrm>
            <a:off x="1726967" y="3429000"/>
            <a:ext cx="42013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7">
            <a:extLst>
              <a:ext uri="{FF2B5EF4-FFF2-40B4-BE49-F238E27FC236}">
                <a16:creationId xmlns:a16="http://schemas.microsoft.com/office/drawing/2014/main" id="{45746DD2-7A48-2580-535D-1A12326D8E3C}"/>
              </a:ext>
            </a:extLst>
          </p:cNvPr>
          <p:cNvSpPr txBox="1"/>
          <p:nvPr/>
        </p:nvSpPr>
        <p:spPr>
          <a:xfrm>
            <a:off x="2221253" y="5572898"/>
            <a:ext cx="8467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The </a:t>
            </a:r>
            <a:r>
              <a:rPr lang="de-DE" dirty="0" err="1"/>
              <a:t>labelled</a:t>
            </a:r>
            <a:r>
              <a:rPr lang="de-DE" dirty="0"/>
              <a:t> </a:t>
            </a:r>
            <a:r>
              <a:rPr lang="de-DE" dirty="0" err="1"/>
              <a:t>fragment</a:t>
            </a:r>
            <a:r>
              <a:rPr lang="de-DE" dirty="0"/>
              <a:t> </a:t>
            </a:r>
            <a:r>
              <a:rPr lang="de-DE" dirty="0" err="1"/>
              <a:t>corresponds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PCR </a:t>
            </a:r>
            <a:r>
              <a:rPr lang="de-DE" dirty="0" err="1"/>
              <a:t>product</a:t>
            </a:r>
            <a:r>
              <a:rPr lang="de-DE" dirty="0"/>
              <a:t> </a:t>
            </a:r>
            <a:r>
              <a:rPr lang="de-DE" dirty="0" err="1"/>
              <a:t>used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EMSA </a:t>
            </a:r>
            <a:r>
              <a:rPr lang="de-DE" dirty="0" err="1"/>
              <a:t>assay</a:t>
            </a:r>
            <a:r>
              <a:rPr lang="de-DE" dirty="0"/>
              <a:t> (284 bp).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F62DFC8D-BF6E-0645-C323-694AB318DB36}"/>
              </a:ext>
            </a:extLst>
          </p:cNvPr>
          <p:cNvSpPr txBox="1"/>
          <p:nvPr/>
        </p:nvSpPr>
        <p:spPr>
          <a:xfrm>
            <a:off x="821560" y="3244333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84 bp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0FEE427F-F46B-0C56-0658-7AF43F5FD87A}"/>
              </a:ext>
            </a:extLst>
          </p:cNvPr>
          <p:cNvSpPr txBox="1"/>
          <p:nvPr/>
        </p:nvSpPr>
        <p:spPr>
          <a:xfrm>
            <a:off x="6433494" y="3411150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84 bp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4FDAA8BC-0BE4-B941-9DC6-C2C53F204F11}"/>
              </a:ext>
            </a:extLst>
          </p:cNvPr>
          <p:cNvSpPr txBox="1"/>
          <p:nvPr/>
        </p:nvSpPr>
        <p:spPr>
          <a:xfrm>
            <a:off x="0" y="0"/>
            <a:ext cx="39231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Tenorite" panose="00000500000000000000" pitchFamily="2" charset="0"/>
              </a:rPr>
              <a:t>Supplementary</a:t>
            </a:r>
            <a:r>
              <a:rPr lang="de-DE" dirty="0">
                <a:latin typeface="Tenorite" panose="00000500000000000000" pitchFamily="2" charset="0"/>
              </a:rPr>
              <a:t> </a:t>
            </a:r>
            <a:r>
              <a:rPr lang="de-DE">
                <a:latin typeface="Tenorite" panose="00000500000000000000" pitchFamily="2" charset="0"/>
              </a:rPr>
              <a:t>Figure 15 </a:t>
            </a:r>
            <a:r>
              <a:rPr lang="de-DE" dirty="0">
                <a:latin typeface="Tenorite" panose="00000500000000000000" pitchFamily="2" charset="0"/>
              </a:rPr>
              <a:t>(Raw </a:t>
            </a:r>
            <a:r>
              <a:rPr lang="de-DE" dirty="0" err="1">
                <a:latin typeface="Tenorite" panose="00000500000000000000" pitchFamily="2" charset="0"/>
              </a:rPr>
              <a:t>data</a:t>
            </a:r>
            <a:r>
              <a:rPr lang="de-DE" dirty="0">
                <a:latin typeface="Tenorite" panose="00000500000000000000" pitchFamily="2" charset="0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785474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norite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bert Warneke</dc:creator>
  <cp:lastModifiedBy>TU-Pseudonym 9837692817497485</cp:lastModifiedBy>
  <cp:revision>7</cp:revision>
  <dcterms:created xsi:type="dcterms:W3CDTF">2024-07-15T14:26:38Z</dcterms:created>
  <dcterms:modified xsi:type="dcterms:W3CDTF">2024-07-19T16:23:36Z</dcterms:modified>
</cp:coreProperties>
</file>